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6" r:id="rId2"/>
    <p:sldId id="279" r:id="rId3"/>
    <p:sldId id="269" r:id="rId4"/>
    <p:sldId id="26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19/6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448767" y="4255947"/>
            <a:ext cx="5852816" cy="542584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r>
              <a:rPr lang="en-US" sz="1465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Fig. 1-</a:t>
            </a:r>
            <a:r>
              <a:rPr lang="en-US" sz="1465" b="1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s1</a:t>
            </a:r>
            <a:r>
              <a:rPr lang="en-US" sz="1465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. </a:t>
            </a:r>
            <a:r>
              <a:rPr lang="en-US" sz="1465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Morphological  observation of  </a:t>
            </a:r>
            <a:r>
              <a:rPr lang="en-US" sz="1465" dirty="0" err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MU1</a:t>
            </a:r>
            <a:r>
              <a:rPr lang="en-US" sz="1465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fish by phase contrast and fluorescent microscopy.</a:t>
            </a:r>
            <a:endParaRPr lang="en-US" altLang="en-US" sz="1465" i="1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671" y="2838123"/>
            <a:ext cx="1914654" cy="127331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8234" y="2838123"/>
            <a:ext cx="1913240" cy="127237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6383" y="2844205"/>
            <a:ext cx="1915200" cy="1273678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448767" y="2838123"/>
            <a:ext cx="1102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</a:rPr>
              <a:t>Phase contrast</a:t>
            </a:r>
            <a:endParaRPr lang="zh-CN" altLang="en-US" sz="1200" dirty="0">
              <a:solidFill>
                <a:schemeClr val="bg1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448234" y="2838123"/>
            <a:ext cx="1162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C00000"/>
                </a:solidFill>
              </a:rPr>
              <a:t>Red fluorescent</a:t>
            </a:r>
            <a:endParaRPr lang="zh-CN" altLang="en-US" sz="1200" dirty="0">
              <a:solidFill>
                <a:srgbClr val="C000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361474" y="2856084"/>
            <a:ext cx="6717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</a:rPr>
              <a:t>Merged</a:t>
            </a:r>
            <a:endParaRPr lang="zh-CN" altLang="en-US" sz="1200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文本框 100"/>
          <p:cNvSpPr txBox="1"/>
          <p:nvPr/>
        </p:nvSpPr>
        <p:spPr>
          <a:xfrm>
            <a:off x="831771" y="1919803"/>
            <a:ext cx="4127500" cy="39116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Tab S1.</a:t>
            </a:r>
            <a:r>
              <a:rPr lang="en-US" sz="13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sz="13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rimers used for qPCR validation</a:t>
            </a:r>
            <a:endParaRPr lang="en-US" altLang="en-US" sz="130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graphicFrame>
        <p:nvGraphicFramePr>
          <p:cNvPr id="4" name="表格 3"/>
          <p:cNvGraphicFramePr/>
          <p:nvPr>
            <p:extLst>
              <p:ext uri="{D42A27DB-BD31-4B8C-83A1-F6EECF244321}">
                <p14:modId xmlns:p14="http://schemas.microsoft.com/office/powerpoint/2010/main" val="770539688"/>
              </p:ext>
            </p:extLst>
          </p:nvPr>
        </p:nvGraphicFramePr>
        <p:xfrm>
          <a:off x="945515" y="2413000"/>
          <a:ext cx="4794250" cy="210185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991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583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367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72415">
                <a:tc>
                  <a:txBody>
                    <a:bodyPr/>
                    <a:lstStyle/>
                    <a:p>
                      <a:pPr indent="0" algn="ctr">
                        <a:lnSpc>
                          <a:spcPct val="160000"/>
                        </a:lnSpc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ene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60000"/>
                        </a:lnSpc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Forward sequences 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60000"/>
                        </a:lnSpc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everse sequences 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i="1" dirty="0" err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apdh</a:t>
                      </a:r>
                      <a:endParaRPr lang="en-US" altLang="en-US" sz="900" b="0" i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ATCTGGCATCACACCTTCTAC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TCCACAGGACTCCATACCA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24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i="1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ct3</a:t>
                      </a:r>
                      <a:endParaRPr lang="en-US" altLang="en-US" sz="900" b="0" i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GAGAGCCAGACGGATATAGAG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CGGATGATGTCTTCACAGAT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35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i="1" dirty="0" err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px</a:t>
                      </a:r>
                      <a:endParaRPr lang="en-US" altLang="en-US" sz="900" b="0" i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GTTTCTGGATGAGGTGGATAAG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CTCCAGGAGCTTCAACAAA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i="1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s</a:t>
                      </a:r>
                      <a:r>
                        <a:rPr lang="en-US" sz="900" b="0" i="1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lc25a33</a:t>
                      </a:r>
                      <a:endParaRPr lang="en-US" altLang="en-US" sz="900" b="0" i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CCGACTTCCTGAGCCTTAT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GTATTTGCTGCCCTCTTCTC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i="1" dirty="0" err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st</a:t>
                      </a:r>
                      <a:endParaRPr lang="en-US" altLang="en-US" sz="900" b="0" i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GACACATACGCTGAGGGT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AGACTGCGGACTTTGGCT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35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i="1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k</a:t>
                      </a:r>
                      <a:endParaRPr lang="en-US" altLang="en-US" sz="900" b="0" i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TGGCAGCAAGGTCTACATC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AGAGTTCCTCCGTTCTCAATC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i="1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am</a:t>
                      </a:r>
                      <a:endParaRPr lang="en-US" altLang="en-US" sz="900" b="0" i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CAGAGCTTCAGGACATGATTA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TCACTATCCGTGTCCTTCATC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224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i="1" dirty="0" err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fka</a:t>
                      </a:r>
                      <a:endParaRPr lang="en-US" altLang="en-US" sz="900" b="0" i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CCAGACAGAAGTATGAGGAAC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TATCGGCTCCAATGCTGAA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35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i="1" dirty="0" err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ktl</a:t>
                      </a:r>
                      <a:endParaRPr lang="en-US" altLang="en-US" sz="900" b="0" i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GCCAACAAGCTCAGGATTA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TGGAAGAACAGCACAGACA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i="1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m</a:t>
                      </a:r>
                      <a:r>
                        <a:rPr lang="en-US" sz="900" b="0" i="1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p2k2</a:t>
                      </a:r>
                      <a:endParaRPr lang="en-US" altLang="en-US" sz="900" b="0" i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ACCACAGGATCCAACATAGG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CTGATTGCTTGCTTGATCTCC</a:t>
                      </a:r>
                      <a:endParaRPr lang="en-US" altLang="en-US" sz="900" b="0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文本框 100"/>
          <p:cNvSpPr txBox="1"/>
          <p:nvPr/>
        </p:nvSpPr>
        <p:spPr>
          <a:xfrm>
            <a:off x="831771" y="1919803"/>
            <a:ext cx="4127500" cy="39116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Tab S2.</a:t>
            </a:r>
            <a:r>
              <a:rPr lang="en-US" sz="13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Frequency distribution of Splicing length</a:t>
            </a:r>
            <a:endParaRPr lang="en-US" altLang="en-US" sz="130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graphicFrame>
        <p:nvGraphicFramePr>
          <p:cNvPr id="2" name="表格 1"/>
          <p:cNvGraphicFramePr/>
          <p:nvPr/>
        </p:nvGraphicFramePr>
        <p:xfrm>
          <a:off x="972472" y="2424390"/>
          <a:ext cx="4784440" cy="145907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453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9872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3144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417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4053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6642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6408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5451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597972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1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min length</a:t>
                      </a:r>
                      <a:endParaRPr lang="en-US" altLang="en-US" sz="900" b="1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dian length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ax length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an length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50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90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otal nucleotides</a:t>
                      </a:r>
                      <a:endParaRPr lang="en-US" altLang="en-US" sz="9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94360"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0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ranscripts</a:t>
                      </a:r>
                      <a:endParaRPr lang="en-US" altLang="en-US" sz="900" b="0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201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420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50278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885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1714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308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200000"/>
                        </a:lnSpc>
                        <a:buNone/>
                      </a:pPr>
                      <a:r>
                        <a:rPr lang="en-US" sz="900" b="0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9988780</a:t>
                      </a:r>
                      <a:endParaRPr lang="en-US" altLang="en-US" sz="900" b="0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674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Unigenes</a:t>
                      </a:r>
                      <a:endParaRPr lang="en-US" altLang="en-US" sz="9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201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873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0278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298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018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83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15646117</a:t>
                      </a:r>
                      <a:endParaRPr lang="en-US" altLang="en-US" sz="900" b="0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044337" y="1552972"/>
            <a:ext cx="4769326" cy="4914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300" b="1" dirty="0">
                <a:latin typeface="Times New Roman" panose="02020603050405020304" charset="0"/>
                <a:cs typeface="Calibri" panose="020F0502020204030204" charset="0"/>
                <a:sym typeface="+mn-ea"/>
              </a:rPr>
              <a:t>Tab </a:t>
            </a:r>
            <a:r>
              <a:rPr lang="en-US" sz="1300" b="1" dirty="0" err="1">
                <a:latin typeface="Times New Roman" panose="02020603050405020304" charset="0"/>
                <a:cs typeface="Calibri" panose="020F0502020204030204" charset="0"/>
                <a:sym typeface="+mn-ea"/>
              </a:rPr>
              <a:t>S3</a:t>
            </a:r>
            <a:r>
              <a:rPr lang="en-US" sz="1300" b="1" dirty="0">
                <a:latin typeface="Times New Roman" panose="02020603050405020304" charset="0"/>
                <a:cs typeface="Calibri" panose="020F0502020204030204" charset="0"/>
                <a:sym typeface="+mn-ea"/>
              </a:rPr>
              <a:t>. </a:t>
            </a:r>
            <a:r>
              <a:rPr lang="en-US" sz="1300" dirty="0">
                <a:latin typeface="Times New Roman" panose="02020603050405020304" charset="0"/>
                <a:cs typeface="Calibri" panose="020F0502020204030204" charset="0"/>
                <a:sym typeface="+mn-ea"/>
              </a:rPr>
              <a:t>Summary statistics of functional annotation for unigenes in public databases</a:t>
            </a:r>
            <a:endParaRPr lang="en-US" altLang="en-US" sz="1300" dirty="0">
              <a:latin typeface="Times New Roman" panose="02020603050405020304" charset="0"/>
              <a:cs typeface="Calibri" panose="020F0502020204030204" charset="0"/>
              <a:sym typeface="+mn-ea"/>
            </a:endParaRPr>
          </a:p>
        </p:txBody>
      </p:sp>
      <p:graphicFrame>
        <p:nvGraphicFramePr>
          <p:cNvPr id="3" name="表格 2"/>
          <p:cNvGraphicFramePr/>
          <p:nvPr/>
        </p:nvGraphicFramePr>
        <p:xfrm>
          <a:off x="1447801" y="2160866"/>
          <a:ext cx="4097577" cy="169048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537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6537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6683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47015">
                <a:tc>
                  <a:txBody>
                    <a:bodyPr/>
                    <a:lstStyle/>
                    <a:p>
                      <a:pPr indent="0" algn="ctr">
                        <a:lnSpc>
                          <a:spcPct val="140000"/>
                        </a:lnSpc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40000"/>
                        </a:lnSpc>
                        <a:buNone/>
                      </a:pPr>
                      <a:r>
                        <a:rPr lang="en-US" sz="9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Number of Genes</a:t>
                      </a:r>
                      <a:endParaRPr lang="en-US" altLang="en-US" sz="900" b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40000"/>
                        </a:lnSpc>
                        <a:buNone/>
                      </a:pPr>
                      <a:r>
                        <a:rPr lang="en-US" sz="9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Percentage (%)</a:t>
                      </a:r>
                      <a:endParaRPr lang="en-US" altLang="en-US" sz="900" b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661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Annotated in NR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94111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6.61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7134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Annotated in NT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30854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78.78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7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Annotated in KOG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5703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1.49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7134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Annotated in GO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78431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47.22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661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Annotated in PFAM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77763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46.82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89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Annotated in all Databases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9540</a:t>
                      </a:r>
                      <a:endParaRPr lang="en-US" altLang="en-US" sz="9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900" b="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11.76</a:t>
                      </a:r>
                      <a:endParaRPr lang="en-US" altLang="en-US" sz="900" b="0" dirty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55721" marR="55721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1</Words>
  <Application>Microsoft Office PowerPoint</Application>
  <PresentationFormat>A4 纸张(210x297 毫米)</PresentationFormat>
  <Paragraphs>85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Chents</cp:lastModifiedBy>
  <cp:revision>51</cp:revision>
  <dcterms:created xsi:type="dcterms:W3CDTF">2019-04-23T01:49:00Z</dcterms:created>
  <dcterms:modified xsi:type="dcterms:W3CDTF">2019-06-09T01:11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661</vt:lpwstr>
  </property>
</Properties>
</file>